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2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2438" y="9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1530715"/>
              </p:ext>
            </p:extLst>
          </p:nvPr>
        </p:nvGraphicFramePr>
        <p:xfrm>
          <a:off x="304800" y="685800"/>
          <a:ext cx="6324601" cy="84388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11518"/>
                <a:gridCol w="3636645"/>
                <a:gridCol w="1027748"/>
                <a:gridCol w="948690"/>
              </a:tblGrid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Spot No.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/>
                          <a:ea typeface="Calibri"/>
                          <a:cs typeface="Arial"/>
                        </a:rPr>
                        <a:t>Protein name (organism)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ontrol 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10% treatment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</a:tr>
              <a:tr h="23876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lastid glutamine synthetase 2 [T. Aestivum]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utamine synthetase leaf isozyme, Chloroplastic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3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TP synthase beta chain, putative [Oryza sativa Japonica Group]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4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TP synthase beta subunit [Calotheca brizoides]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5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ibulose bisphosphate carboxylase large chain Agrostis stolonifera 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6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edicted: 20 kDa chaperonin, chloroplastic-like (B. distachyon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7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utative chaperonnin 21 precursor [Oryza sativa Japonica]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8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ytosolic heat shock protein 90 [H. vulgare]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9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edicted protein (Hordeum vulgare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0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edicted protein (Hordeum vulgare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1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LMW- glutenin subunit group 3 type II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2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utenin, high molecular weight subunit PC237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3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LMW- glutenin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4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5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6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7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8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9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0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-cys peroxiredoxin BAS1 (Triticum aestivum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1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TP synthase beta subunit [</a:t>
                      </a:r>
                      <a:r>
                        <a:rPr lang="en-GB" sz="120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alotheca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120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brizoides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]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971" t="22057" r="50594" b="75024"/>
          <a:stretch/>
        </p:blipFill>
        <p:spPr bwMode="auto">
          <a:xfrm>
            <a:off x="4940202" y="1143000"/>
            <a:ext cx="423442" cy="3217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463" t="37552" r="48012" b="60950"/>
          <a:stretch/>
        </p:blipFill>
        <p:spPr bwMode="auto">
          <a:xfrm>
            <a:off x="5820136" y="1158555"/>
            <a:ext cx="444670" cy="306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079" t="36806" r="50265" b="60380"/>
          <a:stretch/>
        </p:blipFill>
        <p:spPr bwMode="auto">
          <a:xfrm>
            <a:off x="5820136" y="1553129"/>
            <a:ext cx="428264" cy="275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105" t="24128" r="51278" b="70880"/>
          <a:stretch/>
        </p:blipFill>
        <p:spPr bwMode="auto">
          <a:xfrm>
            <a:off x="4940202" y="1553130"/>
            <a:ext cx="423442" cy="2691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273" t="36243" r="29505" b="62561"/>
          <a:stretch/>
        </p:blipFill>
        <p:spPr bwMode="auto">
          <a:xfrm>
            <a:off x="5820136" y="1941576"/>
            <a:ext cx="444670" cy="344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273" t="37414" r="29505" b="61416"/>
          <a:stretch/>
        </p:blipFill>
        <p:spPr bwMode="auto">
          <a:xfrm>
            <a:off x="5831689" y="2698430"/>
            <a:ext cx="433117" cy="3495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116" t="37023" r="24701" b="61040"/>
          <a:stretch/>
        </p:blipFill>
        <p:spPr bwMode="auto">
          <a:xfrm>
            <a:off x="5831879" y="2332099"/>
            <a:ext cx="416521" cy="2928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308" t="23539" r="39123" b="74003"/>
          <a:stretch/>
        </p:blipFill>
        <p:spPr bwMode="auto">
          <a:xfrm>
            <a:off x="4940201" y="1941576"/>
            <a:ext cx="410644" cy="344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308" t="25997" r="39123" b="71545"/>
          <a:stretch/>
        </p:blipFill>
        <p:spPr bwMode="auto">
          <a:xfrm>
            <a:off x="4953001" y="2687953"/>
            <a:ext cx="410642" cy="360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472" t="24762" r="35039" b="71491"/>
          <a:stretch/>
        </p:blipFill>
        <p:spPr bwMode="auto">
          <a:xfrm>
            <a:off x="4940202" y="2332098"/>
            <a:ext cx="422692" cy="29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200" t="41029" r="23986" b="57182"/>
          <a:stretch/>
        </p:blipFill>
        <p:spPr bwMode="auto">
          <a:xfrm>
            <a:off x="5869040" y="4322236"/>
            <a:ext cx="408202" cy="336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200" t="42375" r="23986" b="55394"/>
          <a:stretch/>
        </p:blipFill>
        <p:spPr bwMode="auto">
          <a:xfrm>
            <a:off x="5876560" y="4721313"/>
            <a:ext cx="411939" cy="31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478" t="42355" r="18244" b="55251"/>
          <a:stretch/>
        </p:blipFill>
        <p:spPr bwMode="auto">
          <a:xfrm>
            <a:off x="5883441" y="8419469"/>
            <a:ext cx="393802" cy="30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413" t="31682" r="33863" b="64858"/>
          <a:stretch/>
        </p:blipFill>
        <p:spPr bwMode="auto">
          <a:xfrm>
            <a:off x="4968268" y="4332517"/>
            <a:ext cx="382577" cy="315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666" t="34370" r="31139" b="61399"/>
          <a:stretch/>
        </p:blipFill>
        <p:spPr bwMode="auto">
          <a:xfrm>
            <a:off x="4968268" y="8424042"/>
            <a:ext cx="401642" cy="3157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413" t="34722" r="33863" b="61399"/>
          <a:stretch/>
        </p:blipFill>
        <p:spPr bwMode="auto">
          <a:xfrm>
            <a:off x="4968270" y="4721315"/>
            <a:ext cx="382576" cy="31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297" t="30471" r="49846" b="65349"/>
          <a:stretch/>
        </p:blipFill>
        <p:spPr bwMode="auto">
          <a:xfrm>
            <a:off x="4953001" y="3549691"/>
            <a:ext cx="402223" cy="350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156" t="30471" r="50978" b="65349"/>
          <a:stretch/>
        </p:blipFill>
        <p:spPr bwMode="auto">
          <a:xfrm>
            <a:off x="4953000" y="3123972"/>
            <a:ext cx="409881" cy="372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38" t="30032" r="47140" b="67023"/>
          <a:stretch/>
        </p:blipFill>
        <p:spPr bwMode="auto">
          <a:xfrm>
            <a:off x="4968269" y="3948811"/>
            <a:ext cx="382576" cy="326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210" t="39938" r="48048" b="57870"/>
          <a:stretch/>
        </p:blipFill>
        <p:spPr bwMode="auto">
          <a:xfrm>
            <a:off x="5869040" y="3549691"/>
            <a:ext cx="411939" cy="350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395" t="39661" r="49460" b="57398"/>
          <a:stretch/>
        </p:blipFill>
        <p:spPr bwMode="auto">
          <a:xfrm>
            <a:off x="5857178" y="3123972"/>
            <a:ext cx="407628" cy="372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808" t="40094" r="45037" b="58213"/>
          <a:stretch/>
        </p:blipFill>
        <p:spPr bwMode="auto">
          <a:xfrm>
            <a:off x="5876560" y="3959786"/>
            <a:ext cx="388245" cy="315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19" t="47720" r="55564" b="49740"/>
          <a:stretch/>
        </p:blipFill>
        <p:spPr bwMode="auto">
          <a:xfrm>
            <a:off x="5887968" y="6172200"/>
            <a:ext cx="403616" cy="3361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225" t="47007" r="52466" b="51079"/>
          <a:stretch/>
        </p:blipFill>
        <p:spPr bwMode="auto">
          <a:xfrm>
            <a:off x="5888608" y="6553200"/>
            <a:ext cx="411082" cy="3200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900" t="44715" r="46575" b="52704"/>
          <a:stretch/>
        </p:blipFill>
        <p:spPr bwMode="auto">
          <a:xfrm>
            <a:off x="5887968" y="5435034"/>
            <a:ext cx="389274" cy="327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844" t="45445" r="49411" b="52642"/>
          <a:stretch/>
        </p:blipFill>
        <p:spPr bwMode="auto">
          <a:xfrm>
            <a:off x="5878221" y="5083947"/>
            <a:ext cx="410277" cy="2926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156" t="45466" r="44057" b="52307"/>
          <a:stretch/>
        </p:blipFill>
        <p:spPr bwMode="auto">
          <a:xfrm>
            <a:off x="5887968" y="5798971"/>
            <a:ext cx="389274" cy="3419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295" t="43945" r="50607" b="53559"/>
          <a:stretch/>
        </p:blipFill>
        <p:spPr bwMode="auto">
          <a:xfrm>
            <a:off x="4988935" y="6553200"/>
            <a:ext cx="380975" cy="3200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744" t="42735" r="53001" b="51365"/>
          <a:stretch/>
        </p:blipFill>
        <p:spPr bwMode="auto">
          <a:xfrm>
            <a:off x="4988935" y="6180852"/>
            <a:ext cx="374709" cy="3275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361" t="39826" r="47837" b="55576"/>
          <a:stretch/>
        </p:blipFill>
        <p:spPr bwMode="auto">
          <a:xfrm>
            <a:off x="4968270" y="5435034"/>
            <a:ext cx="374708" cy="327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558" t="39826" r="49640" b="55328"/>
          <a:stretch/>
        </p:blipFill>
        <p:spPr bwMode="auto">
          <a:xfrm>
            <a:off x="4968269" y="5083946"/>
            <a:ext cx="374709" cy="335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393" t="47714" r="45560" b="49391"/>
          <a:stretch/>
        </p:blipFill>
        <p:spPr bwMode="auto">
          <a:xfrm>
            <a:off x="5888608" y="7274562"/>
            <a:ext cx="399890" cy="345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810" t="47797" r="48562" b="49123"/>
          <a:stretch/>
        </p:blipFill>
        <p:spPr bwMode="auto">
          <a:xfrm>
            <a:off x="5888608" y="6912008"/>
            <a:ext cx="402975" cy="326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72" t="47797" r="50847" b="49331"/>
          <a:stretch/>
        </p:blipFill>
        <p:spPr bwMode="auto">
          <a:xfrm>
            <a:off x="5891981" y="7667797"/>
            <a:ext cx="379017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579" t="48303" r="52532" b="48848"/>
          <a:stretch/>
        </p:blipFill>
        <p:spPr bwMode="auto">
          <a:xfrm>
            <a:off x="5888609" y="8041815"/>
            <a:ext cx="382390" cy="320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645" t="43945" r="47465" b="51541"/>
          <a:stretch/>
        </p:blipFill>
        <p:spPr bwMode="auto">
          <a:xfrm>
            <a:off x="4988935" y="6929566"/>
            <a:ext cx="380975" cy="3094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404" t="44847" r="51067" b="50860"/>
          <a:stretch/>
        </p:blipFill>
        <p:spPr bwMode="auto">
          <a:xfrm>
            <a:off x="4968270" y="8029124"/>
            <a:ext cx="411705" cy="3332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363" t="45007" r="49833" b="50700"/>
          <a:stretch/>
        </p:blipFill>
        <p:spPr bwMode="auto">
          <a:xfrm>
            <a:off x="4964183" y="7642352"/>
            <a:ext cx="415791" cy="340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565" t="45619" r="34233" b="50208"/>
          <a:stretch/>
        </p:blipFill>
        <p:spPr bwMode="auto">
          <a:xfrm>
            <a:off x="4988936" y="8781288"/>
            <a:ext cx="380974" cy="2987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739" t="49926" r="19121" b="48160"/>
          <a:stretch/>
        </p:blipFill>
        <p:spPr bwMode="auto">
          <a:xfrm>
            <a:off x="5881562" y="8769096"/>
            <a:ext cx="410021" cy="2987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228600" y="113147"/>
            <a:ext cx="6553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/>
              <a:t>Supplementary </a:t>
            </a:r>
            <a:r>
              <a:rPr lang="en-GB" sz="1400" b="1"/>
              <a:t>Table </a:t>
            </a:r>
            <a:r>
              <a:rPr lang="en-GB" sz="1400" b="1" smtClean="0"/>
              <a:t>S1</a:t>
            </a:r>
            <a:r>
              <a:rPr lang="en-GB" sz="1400" b="1" dirty="0"/>
              <a:t>: </a:t>
            </a:r>
            <a:r>
              <a:rPr lang="en-GB" sz="1400" dirty="0"/>
              <a:t>List of spots proteins and their putative function and form of each spot  from the 2-DE gel. </a:t>
            </a:r>
          </a:p>
        </p:txBody>
      </p:sp>
    </p:spTree>
    <p:extLst>
      <p:ext uri="{BB962C8B-B14F-4D97-AF65-F5344CB8AC3E}">
        <p14:creationId xmlns:p14="http://schemas.microsoft.com/office/powerpoint/2010/main" val="3577587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0271913"/>
              </p:ext>
            </p:extLst>
          </p:nvPr>
        </p:nvGraphicFramePr>
        <p:xfrm>
          <a:off x="304800" y="685800"/>
          <a:ext cx="6324601" cy="82296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11518"/>
                <a:gridCol w="3636645"/>
                <a:gridCol w="1027748"/>
                <a:gridCol w="948690"/>
              </a:tblGrid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Spot No.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/>
                          <a:ea typeface="Calibri"/>
                          <a:cs typeface="Arial"/>
                        </a:rPr>
                        <a:t>Protein name (organism)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ontrol 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10% treatment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</a:tr>
              <a:tr h="1524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2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ibulose bisphosphate carboxylase large chain Agrostis stolonifera 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43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3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hyll a-b binding protein 1, chloroplastic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4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Thioredoxin peroxidase (Hordeum vulgare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930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5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Elongation factor Tu, chloroplastic (Arabidopsis thaliana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6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ysteine-rich receptor-like protein kinase 10 (Ricinus communis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7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Isocitrate dehydrogenase (Hordeum vulgare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8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ycine rich protein, RNA binding protein (Hordeum vulgare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9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UDP-glucose 6-dehydrogenase (Zea mays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0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otein RAFTIN 1B  (Triticum aestivum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1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Oxygen-evolving enhancer protein 3-1,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lastic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2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Beta-amylase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3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hyll a-b binding protein 1, chloroplastic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4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ibulose-bisphosphate carboxylase small chain 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5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ibulose-bisphosphate carboxylase small chain 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6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ibulose-bisphosphate carboxylase small chain 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7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edicted protein (</a:t>
                      </a:r>
                      <a:r>
                        <a:rPr lang="en-GB" sz="800" b="1" i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 vulgare</a:t>
                      </a:r>
                      <a:r>
                        <a:rPr lang="en-GB" sz="800" b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8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70 kDa heat shock protein (</a:t>
                      </a:r>
                      <a:r>
                        <a:rPr lang="en-GB" sz="800" b="1" i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 vulgare</a:t>
                      </a:r>
                      <a:r>
                        <a:rPr lang="en-GB" sz="800" b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9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ycine rich protein, RNA binding protein (</a:t>
                      </a:r>
                      <a:r>
                        <a:rPr lang="en-GB" sz="800" b="1" i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 vulgare</a:t>
                      </a:r>
                      <a:r>
                        <a:rPr lang="en-GB" sz="800" b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0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ycine rich protein, RNA binding protein (</a:t>
                      </a:r>
                      <a:r>
                        <a:rPr lang="en-GB" sz="800" b="1" i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 vulgare</a:t>
                      </a:r>
                      <a:r>
                        <a:rPr lang="en-GB" sz="800" b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1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Enolase (</a:t>
                      </a:r>
                      <a:r>
                        <a:rPr lang="en-GB" sz="800" b="1" i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 vulgare</a:t>
                      </a:r>
                      <a:r>
                        <a:rPr lang="en-GB" sz="800" b="1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2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utative hydrolase (Arabidopsis thaliana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19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233" t="71777" r="27788" b="22030"/>
          <a:stretch/>
        </p:blipFill>
        <p:spPr bwMode="auto">
          <a:xfrm>
            <a:off x="4922520" y="8178165"/>
            <a:ext cx="487680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163" t="62364" r="14729" b="33996"/>
          <a:stretch/>
        </p:blipFill>
        <p:spPr bwMode="auto">
          <a:xfrm>
            <a:off x="5978074" y="8191500"/>
            <a:ext cx="422728" cy="2933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146" t="63194" r="34303" b="32222"/>
          <a:stretch/>
        </p:blipFill>
        <p:spPr bwMode="auto">
          <a:xfrm>
            <a:off x="4922519" y="8610600"/>
            <a:ext cx="48768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113" t="60794" r="45879" b="35357"/>
          <a:stretch/>
        </p:blipFill>
        <p:spPr bwMode="auto">
          <a:xfrm>
            <a:off x="5989073" y="6705599"/>
            <a:ext cx="411728" cy="3474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31" t="68822" r="46262" b="22554"/>
          <a:stretch/>
        </p:blipFill>
        <p:spPr bwMode="auto">
          <a:xfrm>
            <a:off x="4922919" y="6705600"/>
            <a:ext cx="487281" cy="3474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414" t="58609" r="39568" b="35357"/>
          <a:stretch/>
        </p:blipFill>
        <p:spPr bwMode="auto">
          <a:xfrm>
            <a:off x="5985263" y="7082912"/>
            <a:ext cx="415538" cy="305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414" t="58609" r="39568" b="38374"/>
          <a:stretch/>
        </p:blipFill>
        <p:spPr bwMode="auto">
          <a:xfrm>
            <a:off x="5978074" y="7851216"/>
            <a:ext cx="422727" cy="285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229" t="69853" r="42443" b="22554"/>
          <a:stretch/>
        </p:blipFill>
        <p:spPr bwMode="auto">
          <a:xfrm>
            <a:off x="4922918" y="7082912"/>
            <a:ext cx="487281" cy="305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229" t="63452" r="42443" b="29551"/>
          <a:stretch/>
        </p:blipFill>
        <p:spPr bwMode="auto">
          <a:xfrm>
            <a:off x="4922919" y="7851216"/>
            <a:ext cx="487280" cy="281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137" t="66742" r="29932" b="28564"/>
          <a:stretch/>
        </p:blipFill>
        <p:spPr bwMode="auto">
          <a:xfrm>
            <a:off x="4922919" y="7444835"/>
            <a:ext cx="487280" cy="3275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958" t="58609" r="19994" b="36834"/>
          <a:stretch/>
        </p:blipFill>
        <p:spPr bwMode="auto">
          <a:xfrm>
            <a:off x="5989073" y="7444835"/>
            <a:ext cx="411728" cy="333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139" t="65713" r="37991" b="29456"/>
          <a:stretch/>
        </p:blipFill>
        <p:spPr bwMode="auto">
          <a:xfrm>
            <a:off x="4922520" y="5955696"/>
            <a:ext cx="487680" cy="346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787" t="65713" r="41635" b="29460"/>
          <a:stretch/>
        </p:blipFill>
        <p:spPr bwMode="auto">
          <a:xfrm>
            <a:off x="4922919" y="6324600"/>
            <a:ext cx="487280" cy="3311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810" t="59711" r="35613" b="37376"/>
          <a:stretch/>
        </p:blipFill>
        <p:spPr bwMode="auto">
          <a:xfrm>
            <a:off x="5989073" y="5955696"/>
            <a:ext cx="411727" cy="3228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233" t="60178" r="37763" b="36127"/>
          <a:stretch/>
        </p:blipFill>
        <p:spPr bwMode="auto">
          <a:xfrm>
            <a:off x="5978074" y="6324600"/>
            <a:ext cx="422728" cy="345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739" t="48012" r="19121" b="50074"/>
          <a:stretch/>
        </p:blipFill>
        <p:spPr bwMode="auto">
          <a:xfrm>
            <a:off x="5948250" y="1188718"/>
            <a:ext cx="452552" cy="298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376" t="43303" r="33519" b="51250"/>
          <a:stretch/>
        </p:blipFill>
        <p:spPr bwMode="auto">
          <a:xfrm>
            <a:off x="4956447" y="1188718"/>
            <a:ext cx="458136" cy="298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852" t="49788" r="20154" b="47475"/>
          <a:stretch/>
        </p:blipFill>
        <p:spPr bwMode="auto">
          <a:xfrm>
            <a:off x="5948250" y="1548382"/>
            <a:ext cx="437323" cy="2804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445" t="47682" r="31692" b="48370"/>
          <a:stretch/>
        </p:blipFill>
        <p:spPr bwMode="auto">
          <a:xfrm>
            <a:off x="4956447" y="1554476"/>
            <a:ext cx="458136" cy="2804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159" t="50094" r="28405" b="45246"/>
          <a:stretch/>
        </p:blipFill>
        <p:spPr bwMode="auto">
          <a:xfrm>
            <a:off x="4958140" y="3744246"/>
            <a:ext cx="473450" cy="294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232" t="52424" r="29827" b="45745"/>
          <a:stretch/>
        </p:blipFill>
        <p:spPr bwMode="auto">
          <a:xfrm>
            <a:off x="5948252" y="4502281"/>
            <a:ext cx="437321" cy="309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58" t="51716" r="38903" b="43281"/>
          <a:stretch/>
        </p:blipFill>
        <p:spPr bwMode="auto">
          <a:xfrm>
            <a:off x="5959641" y="4876800"/>
            <a:ext cx="441158" cy="2979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149" t="52952" r="35661" b="42721"/>
          <a:stretch/>
        </p:blipFill>
        <p:spPr bwMode="auto">
          <a:xfrm>
            <a:off x="5989072" y="5234875"/>
            <a:ext cx="411727" cy="31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951" t="54155" r="26805" b="42725"/>
          <a:stretch/>
        </p:blipFill>
        <p:spPr bwMode="auto">
          <a:xfrm>
            <a:off x="5989073" y="5615677"/>
            <a:ext cx="422725" cy="294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928" t="51716" r="16739" b="45819"/>
          <a:stretch/>
        </p:blipFill>
        <p:spPr bwMode="auto">
          <a:xfrm>
            <a:off x="5948251" y="3352800"/>
            <a:ext cx="41275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462" t="53803" r="14095" b="43860"/>
          <a:stretch/>
        </p:blipFill>
        <p:spPr bwMode="auto">
          <a:xfrm>
            <a:off x="5948252" y="4154443"/>
            <a:ext cx="412754" cy="268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903" t="51716" r="14095" b="45794"/>
          <a:stretch/>
        </p:blipFill>
        <p:spPr bwMode="auto">
          <a:xfrm>
            <a:off x="5950250" y="3735464"/>
            <a:ext cx="410756" cy="302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218" t="53761" r="27342" b="41716"/>
          <a:stretch/>
        </p:blipFill>
        <p:spPr bwMode="auto">
          <a:xfrm>
            <a:off x="4956447" y="4110598"/>
            <a:ext cx="494841" cy="312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922" t="53692" r="40899" b="43448"/>
          <a:stretch/>
        </p:blipFill>
        <p:spPr bwMode="auto">
          <a:xfrm>
            <a:off x="4958139" y="4500195"/>
            <a:ext cx="494841" cy="300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666" t="52305" r="42704" b="44141"/>
          <a:stretch/>
        </p:blipFill>
        <p:spPr bwMode="auto">
          <a:xfrm>
            <a:off x="4958139" y="4853855"/>
            <a:ext cx="512173" cy="3438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66" t="55880" r="39910" b="40587"/>
          <a:stretch/>
        </p:blipFill>
        <p:spPr bwMode="auto">
          <a:xfrm>
            <a:off x="4958139" y="5251002"/>
            <a:ext cx="494841" cy="30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474" t="52384" r="38144" b="44590"/>
          <a:stretch/>
        </p:blipFill>
        <p:spPr bwMode="auto">
          <a:xfrm>
            <a:off x="4937758" y="2624689"/>
            <a:ext cx="483859" cy="3065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393" t="41895" r="41202" b="53567"/>
          <a:stretch/>
        </p:blipFill>
        <p:spPr bwMode="auto">
          <a:xfrm>
            <a:off x="4937758" y="2283499"/>
            <a:ext cx="478187" cy="307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30" t="48810" r="45765" b="45888"/>
          <a:stretch/>
        </p:blipFill>
        <p:spPr bwMode="auto">
          <a:xfrm>
            <a:off x="4956447" y="3389308"/>
            <a:ext cx="465170" cy="326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255" t="54112" r="45020" b="40587"/>
          <a:stretch/>
        </p:blipFill>
        <p:spPr bwMode="auto">
          <a:xfrm>
            <a:off x="4958140" y="2971800"/>
            <a:ext cx="457805" cy="314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3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856" t="43613" r="28572" b="53890"/>
          <a:stretch/>
        </p:blipFill>
        <p:spPr bwMode="auto">
          <a:xfrm>
            <a:off x="5948251" y="1878662"/>
            <a:ext cx="442577" cy="3133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4" name="Rectangle 53"/>
          <p:cNvSpPr/>
          <p:nvPr/>
        </p:nvSpPr>
        <p:spPr>
          <a:xfrm>
            <a:off x="228600" y="113147"/>
            <a:ext cx="6553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 smtClean="0"/>
              <a:t>Cont. Supplementary </a:t>
            </a:r>
            <a:r>
              <a:rPr lang="en-GB" sz="1400" b="1" dirty="0"/>
              <a:t>Table 1: </a:t>
            </a:r>
            <a:r>
              <a:rPr lang="en-GB" sz="1400" dirty="0"/>
              <a:t>List of spots proteins and their putative function and form of each spot  from the 2-DE gel. </a:t>
            </a:r>
          </a:p>
        </p:txBody>
      </p:sp>
    </p:spTree>
    <p:extLst>
      <p:ext uri="{BB962C8B-B14F-4D97-AF65-F5344CB8AC3E}">
        <p14:creationId xmlns:p14="http://schemas.microsoft.com/office/powerpoint/2010/main" val="2354298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1586874"/>
              </p:ext>
            </p:extLst>
          </p:nvPr>
        </p:nvGraphicFramePr>
        <p:xfrm>
          <a:off x="304800" y="685800"/>
          <a:ext cx="6324601" cy="5633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11518"/>
                <a:gridCol w="3636645"/>
                <a:gridCol w="1027748"/>
                <a:gridCol w="948690"/>
              </a:tblGrid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Spot No.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/>
                          <a:ea typeface="Calibri"/>
                          <a:cs typeface="Arial"/>
                        </a:rPr>
                        <a:t>Protein name (organism)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ontrol 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10% treatment</a:t>
                      </a:r>
                      <a:endParaRPr lang="en-GB" sz="1200" b="1" kern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/>
                </a:tc>
              </a:tr>
              <a:tr h="152400"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3</a:t>
                      </a: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oteasome subunit alpha type-5-A (Arabidopsis thaliana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43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4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0S proteasome subunit PAE1 (Arabidopsis thaliana)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5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otein-serine/threonine kinase (Glycine max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930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6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L-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scorbat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peroxidase (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vulgar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7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Glycosyltransferas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75 (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Tritic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estiv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8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Reversibly glycosylated polypeptide (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Tritic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estiv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9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Leucin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-rich repeat family protein LRR (Arabidopsis thaliana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0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lcohol dehydrogenase I (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Oryza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eichingeri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1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Fructose-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bisphosphat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aldolas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(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ordeum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vulgare</a:t>
                      </a: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2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eat shock protein 21,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lastic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3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eat shock protein 21,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lastic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4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eat shock protein 21,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lastic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5</a:t>
                      </a:r>
                      <a:endParaRPr lang="en-GB" sz="1100" b="1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Heat shock protein 21, </a:t>
                      </a:r>
                      <a:r>
                        <a:rPr lang="en-GB" sz="8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hloroplastic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56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Proteasome subunit alpha type-5-A (Arabidopsis thaliana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--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374" t="75845" r="40009" b="18892"/>
          <a:stretch/>
        </p:blipFill>
        <p:spPr bwMode="auto">
          <a:xfrm>
            <a:off x="5973944" y="1143000"/>
            <a:ext cx="464550" cy="335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426" t="63194" r="27775" b="32222"/>
          <a:stretch/>
        </p:blipFill>
        <p:spPr bwMode="auto">
          <a:xfrm>
            <a:off x="5022998" y="1143000"/>
            <a:ext cx="425032" cy="335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100" t="61241" r="29588" b="36127"/>
          <a:stretch/>
        </p:blipFill>
        <p:spPr bwMode="auto">
          <a:xfrm>
            <a:off x="5973944" y="1524000"/>
            <a:ext cx="46455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471" t="59388" r="32787" b="38253"/>
          <a:stretch/>
        </p:blipFill>
        <p:spPr bwMode="auto">
          <a:xfrm>
            <a:off x="5969143" y="5943600"/>
            <a:ext cx="469351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572" t="60419" r="47347" b="33984"/>
          <a:stretch/>
        </p:blipFill>
        <p:spPr bwMode="auto">
          <a:xfrm>
            <a:off x="5022998" y="3017426"/>
            <a:ext cx="424528" cy="302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786" t="57191" r="42694" b="38802"/>
          <a:stretch/>
        </p:blipFill>
        <p:spPr bwMode="auto">
          <a:xfrm>
            <a:off x="5969143" y="3364154"/>
            <a:ext cx="464550" cy="3696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527" t="57418" r="48931" b="39586"/>
          <a:stretch/>
        </p:blipFill>
        <p:spPr bwMode="auto">
          <a:xfrm>
            <a:off x="5969143" y="2978849"/>
            <a:ext cx="464550" cy="312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85" t="56972" r="32083" b="40099"/>
          <a:stretch/>
        </p:blipFill>
        <p:spPr bwMode="auto">
          <a:xfrm>
            <a:off x="5969143" y="5257801"/>
            <a:ext cx="464549" cy="2808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524" t="56396" r="25098" b="40676"/>
          <a:stretch/>
        </p:blipFill>
        <p:spPr bwMode="auto">
          <a:xfrm>
            <a:off x="5969143" y="5611903"/>
            <a:ext cx="464550" cy="304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380" t="60318" r="37934" b="32125"/>
          <a:stretch/>
        </p:blipFill>
        <p:spPr bwMode="auto">
          <a:xfrm>
            <a:off x="5060807" y="5639051"/>
            <a:ext cx="406543" cy="304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93" t="60317" r="40621" b="32724"/>
          <a:stretch/>
        </p:blipFill>
        <p:spPr bwMode="auto">
          <a:xfrm>
            <a:off x="5060807" y="5257801"/>
            <a:ext cx="416631" cy="296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854" t="32057" r="47760" b="63633"/>
          <a:stretch/>
        </p:blipFill>
        <p:spPr bwMode="auto">
          <a:xfrm>
            <a:off x="5046550" y="4867395"/>
            <a:ext cx="420800" cy="3263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658" t="41190" r="46082" b="56786"/>
          <a:stretch/>
        </p:blipFill>
        <p:spPr bwMode="auto">
          <a:xfrm>
            <a:off x="5973944" y="4855615"/>
            <a:ext cx="459748" cy="3381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790" t="51342" r="22210" b="46204"/>
          <a:stretch/>
        </p:blipFill>
        <p:spPr bwMode="auto">
          <a:xfrm>
            <a:off x="5973944" y="4114800"/>
            <a:ext cx="459748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266" t="50094" r="33770" b="46933"/>
          <a:stretch/>
        </p:blipFill>
        <p:spPr bwMode="auto">
          <a:xfrm>
            <a:off x="5036726" y="4114800"/>
            <a:ext cx="4108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010" t="58024" r="28410" b="36984"/>
          <a:stretch/>
        </p:blipFill>
        <p:spPr bwMode="auto">
          <a:xfrm>
            <a:off x="5037230" y="2625242"/>
            <a:ext cx="410296" cy="3055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540" t="68595" r="32018" b="26169"/>
          <a:stretch/>
        </p:blipFill>
        <p:spPr bwMode="auto">
          <a:xfrm>
            <a:off x="5046550" y="2241046"/>
            <a:ext cx="407443" cy="301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98" t="68595" r="33784" b="26169"/>
          <a:stretch/>
        </p:blipFill>
        <p:spPr bwMode="auto">
          <a:xfrm>
            <a:off x="5022998" y="1906696"/>
            <a:ext cx="432855" cy="3066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111" t="61091" r="24625" b="36162"/>
          <a:stretch/>
        </p:blipFill>
        <p:spPr bwMode="auto">
          <a:xfrm>
            <a:off x="5969008" y="1922624"/>
            <a:ext cx="464684" cy="2907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2118" t="55317" r="13768" b="42186"/>
          <a:stretch/>
        </p:blipFill>
        <p:spPr bwMode="auto">
          <a:xfrm>
            <a:off x="5973943" y="4480560"/>
            <a:ext cx="459747" cy="3200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2" descr="C:\Users\MOHMED\Desktop\30-3-2022 الشعير\38c8f496-eb5b-446f-9f91-d5434f334fb8.jpg"/>
          <p:cNvPicPr>
            <a:picLocks noChangeAspect="1" noChangeArrowheads="1"/>
          </p:cNvPicPr>
          <p:nvPr/>
        </p:nvPicPr>
        <p:blipFill rotWithShape="1">
          <a:blip r:embed="rId4">
            <a:lum bright="10000" contras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467" t="55348" r="14709" b="41585"/>
          <a:stretch/>
        </p:blipFill>
        <p:spPr bwMode="auto">
          <a:xfrm>
            <a:off x="5969007" y="2643303"/>
            <a:ext cx="464684" cy="2874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3" descr="C:\Users\MOHMED\Desktop\30-3-2022 الشعير\b914e26f-ae6c-47c0-b48a-19969d70c012.jpg"/>
          <p:cNvPicPr>
            <a:picLocks noChangeAspect="1" noChangeArrowheads="1"/>
          </p:cNvPicPr>
          <p:nvPr/>
        </p:nvPicPr>
        <p:blipFill rotWithShape="1">
          <a:blip r:embed="rId2">
            <a:lum contrast="1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941" t="47312" r="42553" b="47669"/>
          <a:stretch/>
        </p:blipFill>
        <p:spPr bwMode="auto">
          <a:xfrm>
            <a:off x="5022998" y="3733800"/>
            <a:ext cx="424528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Rectangle 24"/>
          <p:cNvSpPr/>
          <p:nvPr/>
        </p:nvSpPr>
        <p:spPr>
          <a:xfrm>
            <a:off x="228600" y="113147"/>
            <a:ext cx="6553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 smtClean="0"/>
              <a:t>Cont. Supplementary </a:t>
            </a:r>
            <a:r>
              <a:rPr lang="en-GB" sz="1400" b="1" dirty="0"/>
              <a:t>Table 1: </a:t>
            </a:r>
            <a:r>
              <a:rPr lang="en-GB" sz="1400" dirty="0"/>
              <a:t>List of spots proteins and their putative function and form of each spot  from the 2-DE gel. </a:t>
            </a:r>
          </a:p>
        </p:txBody>
      </p:sp>
    </p:spTree>
    <p:extLst>
      <p:ext uri="{BB962C8B-B14F-4D97-AF65-F5344CB8AC3E}">
        <p14:creationId xmlns:p14="http://schemas.microsoft.com/office/powerpoint/2010/main" val="2383422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8</TotalTime>
  <Words>571</Words>
  <Application>Microsoft Office PowerPoint</Application>
  <PresentationFormat>On-screen Show (4:3)</PresentationFormat>
  <Paragraphs>14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33</cp:revision>
  <dcterms:created xsi:type="dcterms:W3CDTF">2006-08-16T00:00:00Z</dcterms:created>
  <dcterms:modified xsi:type="dcterms:W3CDTF">2025-12-26T14:36:32Z</dcterms:modified>
</cp:coreProperties>
</file>